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FB0C16-87F1-47E3-B82C-BFD7F3B790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3720FF-277B-4CF0-AC3B-52E019B283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DB65FA-A460-4945-8BED-C8F27A8B61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CD4B4-05A9-43C2-9ABE-A24A5B4EC4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7E317-ADC2-4614-B9B9-691E7A2ACB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2D682-2724-4F88-BA5E-456B9F762E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B3FA5-97A1-4D00-A622-6669713D38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4E9D4-DD5B-455B-8E25-C0E65784F8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C8C280-1A58-48A6-ABFE-33F2E93FF1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77DA0-2A25-4B9A-B032-121F6ECA62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8BAAAA-B15C-417D-8B42-9F5D7C87EE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3DBC67-51AD-445C-A8F0-2DAA6C88DE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D9C3952-8C50-4D6D-A952-86B796D1D3AC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image" Target="../media/image3.jpe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71600" y="34448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50000"/>
              </a:lnSpc>
              <a:spcAft>
                <a:spcPts val="601"/>
              </a:spcAft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Analysis of Ani s 7 and Ani s 1 allergens as biomarkers of sensitization and allergy severity in human anisakiasis</a:t>
            </a:r>
            <a:br>
              <a:rPr sz="1400"/>
            </a:br>
            <a:r>
              <a:rPr b="0" lang="es-E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Leticia de las Vecillas1.6, Pedro Muñoz-Cacho3,6, Marcos López-Hoyos2, Vittoria Monttecchiani1, Victoria Martínez-Sernández4,5, Florencio M. Ubeira4,5, Fernando Rodríguez-Fernández1.</a:t>
            </a:r>
            <a:br>
              <a:rPr sz="1400"/>
            </a:br>
            <a:br>
              <a:rPr sz="1400"/>
            </a:br>
            <a:r>
              <a:rPr b="0" lang="es-E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1 Department of Allergy, Marqués de Valdecilla University Hospital-IDIVAL, Santander, Spain</a:t>
            </a:r>
            <a:br>
              <a:rPr sz="1400"/>
            </a:br>
            <a:r>
              <a:rPr b="0" lang="es-E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2 Department of Immunology, Marqués de Valdecilla University Hospital- IDIVAL, Santander, Spain</a:t>
            </a:r>
            <a:br>
              <a:rPr sz="1400"/>
            </a:br>
            <a:r>
              <a:rPr b="0" lang="es-E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3  Gerencia Atención Primaria, Servicio Cántabro de Salud, Spain</a:t>
            </a:r>
            <a:br>
              <a:rPr sz="1400"/>
            </a:br>
            <a:r>
              <a:rPr b="0" lang="es-E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4 Department of Microbiology and Parasitology, Faculty of Pharmacy, University of Santiago de Compostela, Santiago de Compostela, Spain</a:t>
            </a:r>
            <a:br>
              <a:rPr sz="1400"/>
            </a:br>
            <a:r>
              <a:rPr b="0" lang="es-E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5 Instituto de Investigación en Análisis Químicos y Biológicos (IAQBUS), Universidad de Santiago de Compostela, Santiago de Compostela, Spain</a:t>
            </a:r>
            <a:br>
              <a:rPr sz="1400"/>
            </a:br>
            <a:r>
              <a:rPr b="0" lang="es-E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6 These authors contribute equally: Leticia de las Vecillas-Sanchez and Pedro Muñoz-Cacho</a:t>
            </a:r>
            <a:br>
              <a:rPr sz="1400"/>
            </a:br>
            <a:br>
              <a:rPr sz="1400"/>
            </a:br>
            <a:br>
              <a:rPr sz="1400"/>
            </a:br>
            <a:r>
              <a:rPr b="0" lang="es-E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To whom correspondence should be addressed:</a:t>
            </a:r>
            <a:br>
              <a:rPr sz="1400"/>
            </a:br>
            <a:r>
              <a:rPr b="0" lang="es-E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Leticia de las Vecillas, MD. Department of Allergy, Marqués de Valdecilla University Hospital-Instituto de Investigación Marqués de Valdecilla, Santander, Spain; Email: leticia.delasveci@gmail.com </a:t>
            </a:r>
            <a:endParaRPr b="0" lang="en-US" sz="1400" spc="-1" strike="noStrike">
              <a:solidFill>
                <a:srgbClr val="000000"/>
              </a:solidFill>
              <a:latin typeface="Calibri Ligh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Marcador de contenido 2"/>
          <p:cNvSpPr/>
          <p:nvPr/>
        </p:nvSpPr>
        <p:spPr>
          <a:xfrm>
            <a:off x="428760" y="5326200"/>
            <a:ext cx="6026040" cy="102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66000"/>
          </a:bodyPr>
          <a:p>
            <a:pPr algn="just">
              <a:lnSpc>
                <a:spcPct val="10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Clinical and diagnostic test results in the Blood donors’ population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rom 403 blood donors, 53 had positive levels of Anisakis-sIgE (≥0.35KUA/L, ImmunoCAP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®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sIgE to rAni s 1 and rAni s 7 were analyzed by ELISA in 46 asymptomatic blood donors with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isaki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sIgE greater than 0.35 KUA/L (n=47). A clinical follow-up were done in 31 of them and SPT were performed in 21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¥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ients presenting allergic symptoms</a:t>
            </a:r>
            <a:r>
              <a:rPr b="0" lang="es-E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ed to recent consumption of fish. 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§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ients with urticaria, not related to recent consumption of fish. 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¤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ients with gastrointestinal disorders not related to recent consumption of fish. 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¶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ients without symptoms related to recent consumption of fish. CRD, component resolve diagnostic test. SPT, skin prick test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ángulo 1"/>
          <p:cNvSpPr/>
          <p:nvPr/>
        </p:nvSpPr>
        <p:spPr>
          <a:xfrm>
            <a:off x="1742400" y="200160"/>
            <a:ext cx="3373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_tradnl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MATERIA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Imagen 2" descr="Captura de pantalla de un celular&#10;&#10;Descripción generada automáticamente"/>
          <p:cNvPicPr/>
          <p:nvPr/>
        </p:nvPicPr>
        <p:blipFill>
          <a:blip r:embed="rId1">
            <a:grayscl/>
          </a:blip>
          <a:stretch/>
        </p:blipFill>
        <p:spPr>
          <a:xfrm>
            <a:off x="0" y="942840"/>
            <a:ext cx="6858000" cy="4010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"/>
          <p:cNvGraphicFramePr/>
          <p:nvPr/>
        </p:nvGraphicFramePr>
        <p:xfrm>
          <a:off x="187200" y="297000"/>
          <a:ext cx="6485040" cy="8159760"/>
        </p:xfrm>
        <a:graphic>
          <a:graphicData uri="http://schemas.openxmlformats.org/drawingml/2006/table">
            <a:tbl>
              <a:tblPr/>
              <a:tblGrid>
                <a:gridCol w="1927440"/>
                <a:gridCol w="1476360"/>
                <a:gridCol w="1033560"/>
                <a:gridCol w="1174680"/>
                <a:gridCol w="873000"/>
              </a:tblGrid>
              <a:tr h="456840">
                <a:tc gridSpan="2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lergic (n=49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ymptomatic (n=46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equency, n (%)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4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iar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10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 (6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-3 times/wee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 (57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 (56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-2 times/wee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 (20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 (34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1 times/wee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 (12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2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servation, n (%)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es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 (7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 (84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8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ltra-Froze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10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 (1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ozen at ho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 (35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 (25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sumption, n (%)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staurant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3 (28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 (2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 ho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43 (93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35 (97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ckagin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5 (10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2 (5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9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paration, n (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8 (16.7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 (2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oil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6 (33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1 (25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8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i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34 (70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36 (81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ast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0 (20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7 (38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6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rinat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9 (18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3 (6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ecies, n (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ak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 (65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 (6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6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chovy/Boquer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39 (79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26 (65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n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 (36.7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 (37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4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bacor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29 (59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23 (57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3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rdi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22 (44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8 (45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9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24 (49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21 (52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4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ource, n (%)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29 (72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3 (52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nn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8 (45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0 (40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9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ish far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7 (17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1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1 (44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lerance of frozen fis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 (91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 (10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4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w fish consump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 (57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 (3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memade fish-preserv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(22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1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4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</a:tbl>
          </a:graphicData>
        </a:graphic>
      </p:graphicFrame>
      <p:sp>
        <p:nvSpPr>
          <p:cNvPr id="46" name="CuadroTexto 4"/>
          <p:cNvSpPr/>
          <p:nvPr/>
        </p:nvSpPr>
        <p:spPr>
          <a:xfrm>
            <a:off x="103320" y="8712360"/>
            <a:ext cx="6484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1.  Consumption habits in allergic patients and sensitized asymptomatic blood donor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Data extracted from an anonymous questionnaire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CuadroTexto 4"/>
          <p:cNvSpPr/>
          <p:nvPr/>
        </p:nvSpPr>
        <p:spPr>
          <a:xfrm>
            <a:off x="258840" y="8782200"/>
            <a:ext cx="63388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a) Classes of sIgE to 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isakis simplex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asured by ImmunoCAP in allergic patients’ serum and in sensitized to 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isakis simplex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ymptomatic blood donors. b) Optical density values of rAni s 1 ELISA and rAni s 7 ELISA in allergic patients and sensitized asymptomatic blood donor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Values of Ani s1 and Ani s 7 and mean values, distributed by sIg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isakis simplex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InmunoCAP) classes comparing symptomatic and asymptomatic study population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Imagen 6" descr=""/>
          <p:cNvPicPr/>
          <p:nvPr/>
        </p:nvPicPr>
        <p:blipFill>
          <a:blip r:embed="rId1"/>
          <a:srcRect l="0" t="0" r="23616" b="-304"/>
          <a:stretch/>
        </p:blipFill>
        <p:spPr>
          <a:xfrm>
            <a:off x="1711440" y="3103560"/>
            <a:ext cx="3193920" cy="2098800"/>
          </a:xfrm>
          <a:prstGeom prst="rect">
            <a:avLst/>
          </a:prstGeom>
          <a:ln w="0">
            <a:noFill/>
          </a:ln>
        </p:spPr>
      </p:pic>
      <p:pic>
        <p:nvPicPr>
          <p:cNvPr id="49" name="Imagen 8" descr="Captura de pantalla de un celular&#10;&#10;Descripción generada automáticamente"/>
          <p:cNvPicPr/>
          <p:nvPr/>
        </p:nvPicPr>
        <p:blipFill>
          <a:blip r:embed="rId2"/>
          <a:srcRect l="0" t="0" r="21852" b="821"/>
          <a:stretch/>
        </p:blipFill>
        <p:spPr>
          <a:xfrm>
            <a:off x="1711440" y="5554800"/>
            <a:ext cx="3332160" cy="2114280"/>
          </a:xfrm>
          <a:prstGeom prst="rect">
            <a:avLst/>
          </a:prstGeom>
          <a:ln w="0">
            <a:noFill/>
          </a:ln>
        </p:spPr>
      </p:pic>
      <p:pic>
        <p:nvPicPr>
          <p:cNvPr id="50" name="Imagen 9" descr=""/>
          <p:cNvPicPr/>
          <p:nvPr/>
        </p:nvPicPr>
        <p:blipFill>
          <a:blip r:embed="rId3"/>
          <a:stretch/>
        </p:blipFill>
        <p:spPr>
          <a:xfrm>
            <a:off x="1905120" y="774720"/>
            <a:ext cx="2944800" cy="1558800"/>
          </a:xfrm>
          <a:prstGeom prst="rect">
            <a:avLst/>
          </a:prstGeom>
          <a:ln w="0">
            <a:noFill/>
          </a:ln>
        </p:spPr>
      </p:pic>
      <p:sp>
        <p:nvSpPr>
          <p:cNvPr id="51" name="Rectángulo 18"/>
          <p:cNvSpPr/>
          <p:nvPr/>
        </p:nvSpPr>
        <p:spPr>
          <a:xfrm>
            <a:off x="432000" y="450720"/>
            <a:ext cx="34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ángulo 31"/>
          <p:cNvSpPr/>
          <p:nvPr/>
        </p:nvSpPr>
        <p:spPr>
          <a:xfrm>
            <a:off x="435600" y="2610000"/>
            <a:ext cx="35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3" name=""/>
          <p:cNvGraphicFramePr/>
          <p:nvPr/>
        </p:nvGraphicFramePr>
        <p:xfrm>
          <a:off x="676440" y="538200"/>
          <a:ext cx="5181480" cy="2533680"/>
        </p:xfrm>
        <a:graphic>
          <a:graphicData uri="http://schemas.openxmlformats.org/drawingml/2006/table">
            <a:tbl>
              <a:tblPr/>
              <a:tblGrid>
                <a:gridCol w="1295280"/>
                <a:gridCol w="1295280"/>
                <a:gridCol w="1295640"/>
                <a:gridCol w="1295280"/>
              </a:tblGrid>
              <a:tr h="181080">
                <a:tc gridSpan="4"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79280"/>
                          <a:tab algn="l" pos="358920"/>
                          <a:tab algn="l" pos="538200"/>
                          <a:tab algn="l" pos="717480"/>
                          <a:tab algn="l" pos="896760"/>
                          <a:tab algn="l" pos="1076400"/>
                          <a:tab algn="l" pos="1255680"/>
                          <a:tab algn="l" pos="1434960"/>
                          <a:tab algn="l" pos="1614600"/>
                          <a:tab algn="l" pos="1793880"/>
                          <a:tab algn="l" pos="1973160"/>
                          <a:tab algn="l" pos="2152800"/>
                          <a:tab algn="l" pos="2332080"/>
                          <a:tab algn="l" pos="2511360"/>
                          <a:tab algn="l" pos="2690640"/>
                          <a:tab algn="l" pos="2870280"/>
                          <a:tab algn="l" pos="3049560"/>
                          <a:tab algn="l" pos="3228840"/>
                          <a:tab algn="l" pos="3408480"/>
                          <a:tab algn="l" pos="3587760"/>
                        </a:tabLst>
                      </a:pPr>
                      <a:r>
                        <a:rPr b="1" i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isakis</a:t>
                      </a: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sIgE                          Estimated specificity at fixed sensitiv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 w="5760">
                      <a:solidFill>
                        <a:srgbClr val="a5a5a5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nsitiv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ecific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 CI </a:t>
                      </a:r>
                      <a:r>
                        <a:rPr b="1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iter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.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.35 to 93.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6.6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.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.83 to 86.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3.8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52 to 71.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2.0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7.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.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5 to 71.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83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9 to 52.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0.48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 gridSpan="4"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timated sensitivity at fixed specific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ecific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nsitiv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 CI </a:t>
                      </a:r>
                      <a:r>
                        <a:rPr b="1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iter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.18 to 89.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7.0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5.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.86 to 81.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6.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.78 to 77.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21.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7.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.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26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.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40.1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</a:tbl>
          </a:graphicData>
        </a:graphic>
      </p:graphicFrame>
      <p:sp>
        <p:nvSpPr>
          <p:cNvPr id="54" name="Rectangle 1"/>
          <p:cNvSpPr/>
          <p:nvPr/>
        </p:nvSpPr>
        <p:spPr>
          <a:xfrm>
            <a:off x="676440" y="8544600"/>
            <a:ext cx="5419440" cy="42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320" rIns="90000" tIns="152280" bIns="921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s-E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C</a:t>
            </a:r>
            <a:r>
              <a:rPr b="0" lang="es-ES" sz="1000" spc="-1" strike="noStrike" baseline="-30000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s-E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ootstrap confidence interval (1000 iterations; random number seed: 978)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5" name=""/>
          <p:cNvGraphicFramePr/>
          <p:nvPr/>
        </p:nvGraphicFramePr>
        <p:xfrm>
          <a:off x="676440" y="6029280"/>
          <a:ext cx="5181480" cy="2685960"/>
        </p:xfrm>
        <a:graphic>
          <a:graphicData uri="http://schemas.openxmlformats.org/drawingml/2006/table">
            <a:tbl>
              <a:tblPr/>
              <a:tblGrid>
                <a:gridCol w="1295280"/>
                <a:gridCol w="1295280"/>
                <a:gridCol w="1295640"/>
                <a:gridCol w="1295280"/>
              </a:tblGrid>
              <a:tr h="333360">
                <a:tc gridSpan="4"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IgE anti-rAni s 7 (ELISA)  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timated specificity at fixed sensitiv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 w="5760">
                      <a:solidFill>
                        <a:srgbClr val="a5a5a5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nsitiv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ecific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 CI </a:t>
                      </a:r>
                      <a:r>
                        <a:rPr b="1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iter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.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80 to 71.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0.62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5 to 47.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0.11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5 to 39.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0.05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7.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45 to 23.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0.033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43 to 13.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0.000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 gridSpan="4"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timated sensitivity at fixed specific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ecific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nsitiv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 CI </a:t>
                      </a:r>
                      <a:r>
                        <a:rPr b="1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iter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.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.37 to 65.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45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6 to 48.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64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32.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72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7.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.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756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94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</a:tbl>
          </a:graphicData>
        </a:graphic>
      </p:graphicFrame>
      <p:graphicFrame>
        <p:nvGraphicFramePr>
          <p:cNvPr id="56" name=""/>
          <p:cNvGraphicFramePr/>
          <p:nvPr/>
        </p:nvGraphicFramePr>
        <p:xfrm>
          <a:off x="676440" y="3274920"/>
          <a:ext cx="5181480" cy="2686320"/>
        </p:xfrm>
        <a:graphic>
          <a:graphicData uri="http://schemas.openxmlformats.org/drawingml/2006/table">
            <a:tbl>
              <a:tblPr/>
              <a:tblGrid>
                <a:gridCol w="1295280"/>
                <a:gridCol w="1295280"/>
                <a:gridCol w="1295640"/>
                <a:gridCol w="1295280"/>
              </a:tblGrid>
              <a:tr h="333360">
                <a:tc gridSpan="4"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IgE anti-rAni s 1 (ELISA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timated specificity at fixed sensitiv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 w="5760">
                      <a:solidFill>
                        <a:srgbClr val="a5a5a5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nsitiv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ecific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 CI </a:t>
                      </a:r>
                      <a:r>
                        <a:rPr b="1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iter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a5a5a5"/>
                      </a:solidFill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.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26 to 69.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0.05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41.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-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9.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-0.00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7.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6.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-0.016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-0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 gridSpan="4"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timated sensitivity at fixed specific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ecific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nsitiv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 CI </a:t>
                      </a:r>
                      <a:r>
                        <a:rPr b="1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iter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.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.80 to 71.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32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.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12 to 63.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57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4 to 59.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73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7.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809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76320" rIns="76320" tIns="19080" bIns="93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 to 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  <a:tc>
                  <a:txBody>
                    <a:bodyPr lIns="76320" rIns="76320" tIns="19080" bIns="93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.941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6320" marR="76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a5a5a5"/>
                      </a:solidFill>
                    </a:lnB>
                    <a:solidFill>
                      <a:srgbClr val="a5a5a5">
                        <a:alpha val="20000"/>
                      </a:srgbClr>
                    </a:solidFill>
                  </a:tcPr>
                </a:tc>
              </a:tr>
            </a:tbl>
          </a:graphicData>
        </a:graphic>
      </p:graphicFrame>
      <p:sp>
        <p:nvSpPr>
          <p:cNvPr id="57" name="CuadroTexto 4"/>
          <p:cNvSpPr/>
          <p:nvPr/>
        </p:nvSpPr>
        <p:spPr>
          <a:xfrm>
            <a:off x="557280" y="9091440"/>
            <a:ext cx="54198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. Sensitivity and specificity associated with the Youden index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summary table displays the estimated specificity and sensitivity for a range of fixed sensitivities and specificities, respectively, with the corresponding criterion values.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"/>
          <p:cNvGraphicFramePr/>
          <p:nvPr/>
        </p:nvGraphicFramePr>
        <p:xfrm>
          <a:off x="1176480" y="743040"/>
          <a:ext cx="4286160" cy="1434960"/>
        </p:xfrm>
        <a:graphic>
          <a:graphicData uri="http://schemas.openxmlformats.org/drawingml/2006/table">
            <a:tbl>
              <a:tblPr/>
              <a:tblGrid>
                <a:gridCol w="1058760"/>
                <a:gridCol w="650880"/>
                <a:gridCol w="920880"/>
                <a:gridCol w="549000"/>
                <a:gridCol w="549360"/>
                <a:gridCol w="557280"/>
              </a:tblGrid>
              <a:tr h="2869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>
                      <a:noFill/>
                    </a:lnL>
                    <a:lnR w="1368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I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isakis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sI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i s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i s 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DP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7040">
                <a:tc>
                  <a:txBody>
                    <a:bodyPr tIns="44640" bIns="4464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isakis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sI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522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43000">
                <a:tc>
                  <a:txBody>
                    <a:bodyPr tIns="44640" bIns="4464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i s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0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414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41920">
                <a:tc>
                  <a:txBody>
                    <a:bodyPr tIns="44640" bIns="4464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i s 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310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662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527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03400"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DP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876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474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1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327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─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03400"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hrim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618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465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2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430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631</a:t>
                      </a:r>
                      <a:r>
                        <a:rPr b="0" lang="es-E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9" name="Rectangle 4"/>
          <p:cNvSpPr/>
          <p:nvPr/>
        </p:nvSpPr>
        <p:spPr>
          <a:xfrm>
            <a:off x="1176480" y="2521080"/>
            <a:ext cx="4286160" cy="82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S3. Spearman correlation coefficients between levels of total IgE, 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Anisakis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-sIgE (ImmunoCAP), sIgE anti-rAni s 1 and sIgE anti-rAni s 7 (ELISA), sIgE (ImmunoCAP) to DPT and shrimp among asymptomatic sensitized to 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AS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 blood donors.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Calibri"/>
              </a:rPr>
              <a:t>* P &lt; 0.05  ** P &lt; 0.0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2-16T15:42:56Z</dcterms:created>
  <dc:creator>DE LAS VECILLAS SANCHEZ, LETICIA</dc:creator>
  <dc:description/>
  <dc:language>en-US</dc:language>
  <cp:lastModifiedBy>DE LAS VECILLAS SANCHEZ, LETICIA</cp:lastModifiedBy>
  <cp:lastPrinted>2019-10-14T10:26:44Z</cp:lastPrinted>
  <dcterms:modified xsi:type="dcterms:W3CDTF">2020-06-29T10:28:19Z</dcterms:modified>
  <cp:revision>161</cp:revision>
  <dc:subject/>
  <dc:title>Presentación de PowerPoint</dc:title>
</cp:coreProperties>
</file>